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9" autoAdjust="0"/>
    <p:restoredTop sz="94660"/>
  </p:normalViewPr>
  <p:slideViewPr>
    <p:cSldViewPr snapToGrid="0">
      <p:cViewPr>
        <p:scale>
          <a:sx n="141" d="100"/>
          <a:sy n="141" d="100"/>
        </p:scale>
        <p:origin x="-822" y="-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496D1-5935-41B9-BDDE-BA4787A1D2A7}" type="datetimeFigureOut">
              <a:rPr lang="da-DK" smtClean="0"/>
              <a:t>29-06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FDC8A-587B-42CD-AC91-1D9CA8F6142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1595204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496D1-5935-41B9-BDDE-BA4787A1D2A7}" type="datetimeFigureOut">
              <a:rPr lang="da-DK" smtClean="0"/>
              <a:t>29-06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FDC8A-587B-42CD-AC91-1D9CA8F6142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6160938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496D1-5935-41B9-BDDE-BA4787A1D2A7}" type="datetimeFigureOut">
              <a:rPr lang="da-DK" smtClean="0"/>
              <a:t>29-06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FDC8A-587B-42CD-AC91-1D9CA8F6142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0568056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496D1-5935-41B9-BDDE-BA4787A1D2A7}" type="datetimeFigureOut">
              <a:rPr lang="da-DK" smtClean="0"/>
              <a:t>29-06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FDC8A-587B-42CD-AC91-1D9CA8F6142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8659663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496D1-5935-41B9-BDDE-BA4787A1D2A7}" type="datetimeFigureOut">
              <a:rPr lang="da-DK" smtClean="0"/>
              <a:t>29-06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FDC8A-587B-42CD-AC91-1D9CA8F6142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0550349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496D1-5935-41B9-BDDE-BA4787A1D2A7}" type="datetimeFigureOut">
              <a:rPr lang="da-DK" smtClean="0"/>
              <a:t>29-06-2015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FDC8A-587B-42CD-AC91-1D9CA8F6142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2312023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496D1-5935-41B9-BDDE-BA4787A1D2A7}" type="datetimeFigureOut">
              <a:rPr lang="da-DK" smtClean="0"/>
              <a:t>29-06-2015</a:t>
            </a:fld>
            <a:endParaRPr lang="da-DK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FDC8A-587B-42CD-AC91-1D9CA8F6142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6450023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496D1-5935-41B9-BDDE-BA4787A1D2A7}" type="datetimeFigureOut">
              <a:rPr lang="da-DK" smtClean="0"/>
              <a:t>29-06-2015</a:t>
            </a:fld>
            <a:endParaRPr lang="da-DK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FDC8A-587B-42CD-AC91-1D9CA8F6142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613282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496D1-5935-41B9-BDDE-BA4787A1D2A7}" type="datetimeFigureOut">
              <a:rPr lang="da-DK" smtClean="0"/>
              <a:t>29-06-2015</a:t>
            </a:fld>
            <a:endParaRPr lang="da-DK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FDC8A-587B-42CD-AC91-1D9CA8F6142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1194153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496D1-5935-41B9-BDDE-BA4787A1D2A7}" type="datetimeFigureOut">
              <a:rPr lang="da-DK" smtClean="0"/>
              <a:t>29-06-2015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FDC8A-587B-42CD-AC91-1D9CA8F6142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464087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a-DK" smtClean="0"/>
              <a:t>Klik på ikonet for at tilføje et billed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496D1-5935-41B9-BDDE-BA4787A1D2A7}" type="datetimeFigureOut">
              <a:rPr lang="da-DK" smtClean="0"/>
              <a:t>29-06-2015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FDC8A-587B-42CD-AC91-1D9CA8F6142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10435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A496D1-5935-41B9-BDDE-BA4787A1D2A7}" type="datetimeFigureOut">
              <a:rPr lang="da-DK" smtClean="0"/>
              <a:t>29-06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3FDC8A-587B-42CD-AC91-1D9CA8F6142B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676613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led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7073" y="109692"/>
            <a:ext cx="5163578" cy="5163578"/>
          </a:xfrm>
          <a:prstGeom prst="rect">
            <a:avLst/>
          </a:prstGeom>
        </p:spPr>
      </p:pic>
      <p:sp>
        <p:nvSpPr>
          <p:cNvPr id="5" name="Tekstfelt 4"/>
          <p:cNvSpPr txBox="1"/>
          <p:nvPr/>
        </p:nvSpPr>
        <p:spPr>
          <a:xfrm>
            <a:off x="1679944" y="5465135"/>
            <a:ext cx="6262577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smtClean="0"/>
              <a:t>S1 Fig. </a:t>
            </a:r>
            <a:r>
              <a:rPr lang="en-US" sz="1600" dirty="0"/>
              <a:t>White </a:t>
            </a:r>
            <a:r>
              <a:rPr lang="en-US" sz="1600" i="1" dirty="0"/>
              <a:t>A. </a:t>
            </a:r>
            <a:r>
              <a:rPr lang="en-US" sz="1600" i="1" dirty="0" err="1"/>
              <a:t>aculeatus</a:t>
            </a:r>
            <a:r>
              <a:rPr lang="en-US" sz="1600" dirty="0"/>
              <a:t> mutant strains propagate in a phenotypically stable manner. </a:t>
            </a:r>
            <a:r>
              <a:rPr lang="en-US" sz="1600" dirty="0" err="1"/>
              <a:t>Restreaking</a:t>
            </a:r>
            <a:r>
              <a:rPr lang="en-US" sz="1600" dirty="0"/>
              <a:t> of a white strain obtained by RNA guided CRISPR-Cas9 mutagenesis of the </a:t>
            </a:r>
            <a:r>
              <a:rPr lang="en-US" sz="1600" i="1" dirty="0" err="1"/>
              <a:t>albA</a:t>
            </a:r>
            <a:r>
              <a:rPr lang="en-US" sz="1600" dirty="0"/>
              <a:t> locus. The colony was propagated on solid medium without selection.</a:t>
            </a:r>
            <a:endParaRPr lang="da-DK" sz="1600" dirty="0"/>
          </a:p>
        </p:txBody>
      </p:sp>
    </p:spTree>
    <p:extLst>
      <p:ext uri="{BB962C8B-B14F-4D97-AF65-F5344CB8AC3E}">
        <p14:creationId xmlns:p14="http://schemas.microsoft.com/office/powerpoint/2010/main" val="29506248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</TotalTime>
  <Words>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-tema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Cirenya</dc:creator>
  <cp:lastModifiedBy>Uffe Hasbro Mortensen</cp:lastModifiedBy>
  <cp:revision>3</cp:revision>
  <dcterms:created xsi:type="dcterms:W3CDTF">2015-06-06T12:09:08Z</dcterms:created>
  <dcterms:modified xsi:type="dcterms:W3CDTF">2015-06-29T13:03:58Z</dcterms:modified>
</cp:coreProperties>
</file>